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3" r:id="rId2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yle moyen 2 - Accentuation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95" autoAdjust="0"/>
    <p:restoredTop sz="94660"/>
  </p:normalViewPr>
  <p:slideViewPr>
    <p:cSldViewPr snapToGrid="0">
      <p:cViewPr>
        <p:scale>
          <a:sx n="90" d="100"/>
          <a:sy n="90" d="100"/>
        </p:scale>
        <p:origin x="-1440" y="-690"/>
      </p:cViewPr>
      <p:guideLst>
        <p:guide orient="horz" pos="492"/>
        <p:guide pos="425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D8EA8D9-AA9B-44B4-8D43-3BEA004884AE}" type="datetimeFigureOut">
              <a:rPr lang="fr-FR" smtClean="0"/>
              <a:t>01/06/2021</a:t>
            </a:fld>
            <a:endParaRPr lang="fr-FR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fr-FR"/>
          </a:p>
        </p:txBody>
      </p:sp>
      <p:sp>
        <p:nvSpPr>
          <p:cNvPr id="5" name="Espace réservé des note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DBFD854-18DF-40D9-9249-A1F26EB5D596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92592539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image des diapositives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Espace réservé des not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1CC5399E-90B7-479D-A2FE-A95CCDDB503C}" type="slidenum">
              <a:rPr lang="fr-FR" smtClean="0"/>
              <a:t>1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41991233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 smtClean="0"/>
              <a:t>Modifier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459E2F-094B-4455-AF32-DDF2BABC094A}" type="datetimeFigureOut">
              <a:rPr lang="fr-FR" smtClean="0"/>
              <a:t>01/06/2021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7E12EC-9BEB-4EC9-BC91-5BF77F9BC3C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70831367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459E2F-094B-4455-AF32-DDF2BABC094A}" type="datetimeFigureOut">
              <a:rPr lang="fr-FR" smtClean="0"/>
              <a:t>01/06/2021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7E12EC-9BEB-4EC9-BC91-5BF77F9BC3C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71276850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459E2F-094B-4455-AF32-DDF2BABC094A}" type="datetimeFigureOut">
              <a:rPr lang="fr-FR" smtClean="0"/>
              <a:t>01/06/2021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7E12EC-9BEB-4EC9-BC91-5BF77F9BC3C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57201109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459E2F-094B-4455-AF32-DDF2BABC094A}" type="datetimeFigureOut">
              <a:rPr lang="fr-FR" smtClean="0"/>
              <a:t>01/06/2021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7E12EC-9BEB-4EC9-BC91-5BF77F9BC3C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711072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459E2F-094B-4455-AF32-DDF2BABC094A}" type="datetimeFigureOut">
              <a:rPr lang="fr-FR" smtClean="0"/>
              <a:t>01/06/2021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7E12EC-9BEB-4EC9-BC91-5BF77F9BC3C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2003916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459E2F-094B-4455-AF32-DDF2BABC094A}" type="datetimeFigureOut">
              <a:rPr lang="fr-FR" smtClean="0"/>
              <a:t>01/06/2021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7E12EC-9BEB-4EC9-BC91-5BF77F9BC3C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57258014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459E2F-094B-4455-AF32-DDF2BABC094A}" type="datetimeFigureOut">
              <a:rPr lang="fr-FR" smtClean="0"/>
              <a:t>01/06/2021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7E12EC-9BEB-4EC9-BC91-5BF77F9BC3C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03458050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459E2F-094B-4455-AF32-DDF2BABC094A}" type="datetimeFigureOut">
              <a:rPr lang="fr-FR" smtClean="0"/>
              <a:t>01/06/2021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7E12EC-9BEB-4EC9-BC91-5BF77F9BC3C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70792747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459E2F-094B-4455-AF32-DDF2BABC094A}" type="datetimeFigureOut">
              <a:rPr lang="fr-FR" smtClean="0"/>
              <a:t>01/06/2021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7E12EC-9BEB-4EC9-BC91-5BF77F9BC3C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63070716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459E2F-094B-4455-AF32-DDF2BABC094A}" type="datetimeFigureOut">
              <a:rPr lang="fr-FR" smtClean="0"/>
              <a:t>01/06/2021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7E12EC-9BEB-4EC9-BC91-5BF77F9BC3C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38236862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459E2F-094B-4455-AF32-DDF2BABC094A}" type="datetimeFigureOut">
              <a:rPr lang="fr-FR" smtClean="0"/>
              <a:t>01/06/2021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7E12EC-9BEB-4EC9-BC91-5BF77F9BC3C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68246432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E459E2F-094B-4455-AF32-DDF2BABC094A}" type="datetimeFigureOut">
              <a:rPr lang="fr-FR" smtClean="0"/>
              <a:t>01/06/2021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B7E12EC-9BEB-4EC9-BC91-5BF77F9BC3C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27699576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microsoft.com/office/2007/relationships/hdphoto" Target="../media/hdphoto1.wdp"/><Relationship Id="rId5" Type="http://schemas.openxmlformats.org/officeDocument/2006/relationships/image" Target="../media/image3.png"/><Relationship Id="rId4" Type="http://schemas.openxmlformats.org/officeDocument/2006/relationships/image" Target="../media/image2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8" name="Tableau 7"/>
          <p:cNvGraphicFramePr>
            <a:graphicFrameLocks noGrp="1" noChangeAspect="1"/>
          </p:cNvGraphicFramePr>
          <p:nvPr>
            <p:extLst>
              <p:ext uri="{D42A27DB-BD31-4B8C-83A1-F6EECF244321}">
                <p14:modId xmlns:p14="http://schemas.microsoft.com/office/powerpoint/2010/main" val="2093914700"/>
              </p:ext>
            </p:extLst>
          </p:nvPr>
        </p:nvGraphicFramePr>
        <p:xfrm>
          <a:off x="145891" y="1137253"/>
          <a:ext cx="8818571" cy="4470641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979368">
                  <a:extLst>
                    <a:ext uri="{9D8B030D-6E8A-4147-A177-3AD203B41FA5}">
                      <a16:colId xmlns:a16="http://schemas.microsoft.com/office/drawing/2014/main" xmlns="" val="1218100927"/>
                    </a:ext>
                  </a:extLst>
                </a:gridCol>
                <a:gridCol w="931644">
                  <a:extLst>
                    <a:ext uri="{9D8B030D-6E8A-4147-A177-3AD203B41FA5}">
                      <a16:colId xmlns:a16="http://schemas.microsoft.com/office/drawing/2014/main" xmlns="" val="2231586814"/>
                    </a:ext>
                  </a:extLst>
                </a:gridCol>
                <a:gridCol w="841485">
                  <a:extLst>
                    <a:ext uri="{9D8B030D-6E8A-4147-A177-3AD203B41FA5}">
                      <a16:colId xmlns:a16="http://schemas.microsoft.com/office/drawing/2014/main" xmlns="" val="842824571"/>
                    </a:ext>
                  </a:extLst>
                </a:gridCol>
                <a:gridCol w="1342368">
                  <a:extLst>
                    <a:ext uri="{9D8B030D-6E8A-4147-A177-3AD203B41FA5}">
                      <a16:colId xmlns:a16="http://schemas.microsoft.com/office/drawing/2014/main" xmlns="" val="1793184788"/>
                    </a:ext>
                  </a:extLst>
                </a:gridCol>
                <a:gridCol w="1688577">
                  <a:extLst>
                    <a:ext uri="{9D8B030D-6E8A-4147-A177-3AD203B41FA5}">
                      <a16:colId xmlns:a16="http://schemas.microsoft.com/office/drawing/2014/main" xmlns="" val="3135421046"/>
                    </a:ext>
                  </a:extLst>
                </a:gridCol>
                <a:gridCol w="1494503">
                  <a:extLst>
                    <a:ext uri="{9D8B030D-6E8A-4147-A177-3AD203B41FA5}">
                      <a16:colId xmlns:a16="http://schemas.microsoft.com/office/drawing/2014/main" xmlns="" val="600370452"/>
                    </a:ext>
                  </a:extLst>
                </a:gridCol>
                <a:gridCol w="1540626">
                  <a:extLst>
                    <a:ext uri="{9D8B030D-6E8A-4147-A177-3AD203B41FA5}">
                      <a16:colId xmlns:a16="http://schemas.microsoft.com/office/drawing/2014/main" xmlns="" val="3739726703"/>
                    </a:ext>
                  </a:extLst>
                </a:gridCol>
              </a:tblGrid>
              <a:tr h="304164">
                <a:tc rowSpan="2">
                  <a:txBody>
                    <a:bodyPr/>
                    <a:lstStyle/>
                    <a:p>
                      <a:pPr algn="ctr"/>
                      <a:r>
                        <a:rPr lang="fr-FR" sz="1400" dirty="0" err="1" smtClean="0">
                          <a:solidFill>
                            <a:schemeClr val="tx1"/>
                          </a:solidFill>
                        </a:rPr>
                        <a:t>Tumor</a:t>
                      </a:r>
                      <a:r>
                        <a:rPr lang="fr-FR" sz="1400" baseline="0" dirty="0" smtClean="0">
                          <a:solidFill>
                            <a:schemeClr val="tx1"/>
                          </a:solidFill>
                        </a:rPr>
                        <a:t> model  </a:t>
                      </a:r>
                      <a:endParaRPr lang="fr-FR" sz="1400" dirty="0">
                        <a:solidFill>
                          <a:schemeClr val="tx1"/>
                        </a:solidFill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fr-FR" sz="1400" dirty="0" smtClean="0">
                          <a:solidFill>
                            <a:schemeClr val="tx1"/>
                          </a:solidFill>
                        </a:rPr>
                        <a:t>LOX</a:t>
                      </a:r>
                      <a:r>
                        <a:rPr lang="fr-FR" sz="1400" baseline="0" dirty="0" smtClean="0">
                          <a:solidFill>
                            <a:schemeClr val="tx1"/>
                          </a:solidFill>
                        </a:rPr>
                        <a:t> inhibition </a:t>
                      </a:r>
                      <a:endParaRPr lang="fr-FR" sz="1400" dirty="0">
                        <a:solidFill>
                          <a:schemeClr val="tx1"/>
                        </a:solidFill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fr-FR" sz="1400" dirty="0" smtClean="0">
                          <a:solidFill>
                            <a:schemeClr val="tx1"/>
                          </a:solidFill>
                        </a:rPr>
                        <a:t>Type of T </a:t>
                      </a:r>
                      <a:r>
                        <a:rPr lang="fr-FR" sz="1400" dirty="0" err="1" smtClean="0">
                          <a:solidFill>
                            <a:schemeClr val="tx1"/>
                          </a:solidFill>
                        </a:rPr>
                        <a:t>cell</a:t>
                      </a:r>
                      <a:r>
                        <a:rPr lang="fr-FR" sz="1400" dirty="0" smtClean="0">
                          <a:solidFill>
                            <a:schemeClr val="tx1"/>
                          </a:solidFill>
                        </a:rPr>
                        <a:t> </a:t>
                      </a:r>
                      <a:r>
                        <a:rPr lang="fr-FR" sz="1400" dirty="0" err="1" smtClean="0">
                          <a:solidFill>
                            <a:schemeClr val="tx1"/>
                          </a:solidFill>
                        </a:rPr>
                        <a:t>analyzed</a:t>
                      </a:r>
                      <a:endParaRPr lang="fr-FR" sz="1400" dirty="0">
                        <a:solidFill>
                          <a:schemeClr val="tx1"/>
                        </a:solidFill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gridSpan="3">
                  <a:txBody>
                    <a:bodyPr/>
                    <a:lstStyle/>
                    <a:p>
                      <a:pPr algn="ctr"/>
                      <a:r>
                        <a:rPr lang="fr-FR" sz="1400" dirty="0" smtClean="0">
                          <a:solidFill>
                            <a:schemeClr val="tx1"/>
                          </a:solidFill>
                        </a:rPr>
                        <a:t>T</a:t>
                      </a:r>
                      <a:r>
                        <a:rPr lang="fr-FR" sz="1400" baseline="0" dirty="0" smtClean="0">
                          <a:solidFill>
                            <a:schemeClr val="tx1"/>
                          </a:solidFill>
                        </a:rPr>
                        <a:t> </a:t>
                      </a:r>
                      <a:r>
                        <a:rPr lang="fr-FR" sz="1400" baseline="0" dirty="0" err="1" smtClean="0">
                          <a:solidFill>
                            <a:schemeClr val="tx1"/>
                          </a:solidFill>
                        </a:rPr>
                        <a:t>cell</a:t>
                      </a:r>
                      <a:r>
                        <a:rPr lang="fr-FR" sz="1400" baseline="0" dirty="0" smtClean="0">
                          <a:solidFill>
                            <a:schemeClr val="tx1"/>
                          </a:solidFill>
                        </a:rPr>
                        <a:t> migration </a:t>
                      </a:r>
                      <a:r>
                        <a:rPr lang="fr-FR" sz="1400" baseline="0" dirty="0" err="1" smtClean="0">
                          <a:solidFill>
                            <a:schemeClr val="tx1"/>
                          </a:solidFill>
                        </a:rPr>
                        <a:t>parameters</a:t>
                      </a:r>
                      <a:r>
                        <a:rPr lang="fr-FR" sz="1400" baseline="0" dirty="0" smtClean="0">
                          <a:solidFill>
                            <a:schemeClr val="tx1"/>
                          </a:solidFill>
                        </a:rPr>
                        <a:t> </a:t>
                      </a:r>
                      <a:endParaRPr lang="fr-FR" sz="1400" dirty="0">
                        <a:solidFill>
                          <a:schemeClr val="tx1"/>
                        </a:solidFill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fr-FR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fr-FR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fr-FR" sz="1400" dirty="0" smtClean="0">
                          <a:solidFill>
                            <a:schemeClr val="tx1"/>
                          </a:solidFill>
                        </a:rPr>
                        <a:t> CD8/mm</a:t>
                      </a:r>
                      <a:r>
                        <a:rPr lang="fr-FR" sz="1400" baseline="30000" dirty="0" smtClean="0">
                          <a:solidFill>
                            <a:schemeClr val="tx1"/>
                          </a:solidFill>
                        </a:rPr>
                        <a:t>2</a:t>
                      </a:r>
                      <a:endParaRPr lang="fr-FR" sz="1400" baseline="30000" dirty="0">
                        <a:solidFill>
                          <a:schemeClr val="tx1"/>
                        </a:solidFill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3242275614"/>
                  </a:ext>
                </a:extLst>
              </a:tr>
              <a:tr h="700133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400" b="1" dirty="0" smtClean="0"/>
                        <a:t>Migration speed</a:t>
                      </a:r>
                      <a:br>
                        <a:rPr lang="fr-FR" sz="1400" b="1" dirty="0" smtClean="0"/>
                      </a:br>
                      <a:r>
                        <a:rPr lang="fr-FR" sz="1400" b="1" dirty="0" smtClean="0"/>
                        <a:t>(µm/min)</a:t>
                      </a:r>
                      <a:endParaRPr lang="fr-FR" sz="1400" b="1" dirty="0"/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400" b="1" dirty="0" smtClean="0"/>
                        <a:t>T</a:t>
                      </a:r>
                      <a:r>
                        <a:rPr lang="fr-FR" sz="1400" b="1" baseline="0" dirty="0" smtClean="0"/>
                        <a:t> </a:t>
                      </a:r>
                      <a:r>
                        <a:rPr lang="fr-FR" sz="1400" b="1" baseline="0" dirty="0" err="1" smtClean="0"/>
                        <a:t>c</a:t>
                      </a:r>
                      <a:r>
                        <a:rPr lang="fr-FR" sz="1400" b="1" dirty="0" err="1" smtClean="0"/>
                        <a:t>ell</a:t>
                      </a:r>
                      <a:r>
                        <a:rPr lang="fr-FR" sz="1400" b="1" baseline="0" dirty="0" smtClean="0"/>
                        <a:t> </a:t>
                      </a:r>
                      <a:r>
                        <a:rPr lang="fr-FR" sz="1400" b="1" baseline="0" dirty="0" err="1" smtClean="0"/>
                        <a:t>displacement</a:t>
                      </a:r>
                      <a:r>
                        <a:rPr lang="fr-FR" sz="1400" b="1" baseline="0" dirty="0" smtClean="0"/>
                        <a:t/>
                      </a:r>
                      <a:br>
                        <a:rPr lang="fr-FR" sz="1400" b="1" baseline="0" dirty="0" smtClean="0"/>
                      </a:br>
                      <a:r>
                        <a:rPr lang="fr-FR" sz="1400" b="1" baseline="0" dirty="0" smtClean="0"/>
                        <a:t>(µm)</a:t>
                      </a:r>
                      <a:endParaRPr lang="fr-FR" sz="1400" b="1" dirty="0"/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400" b="1" dirty="0" err="1" smtClean="0"/>
                        <a:t>Track</a:t>
                      </a:r>
                      <a:r>
                        <a:rPr lang="fr-FR" sz="1400" b="1" baseline="0" dirty="0" smtClean="0"/>
                        <a:t> </a:t>
                      </a:r>
                      <a:r>
                        <a:rPr lang="fr-FR" sz="1400" b="1" baseline="0" dirty="0" err="1" smtClean="0"/>
                        <a:t>straightness</a:t>
                      </a:r>
                      <a:endParaRPr lang="fr-FR" sz="1400" b="1" baseline="0" dirty="0" smtClean="0"/>
                    </a:p>
                    <a:p>
                      <a:pPr algn="ctr"/>
                      <a:r>
                        <a:rPr lang="fr-FR" sz="1400" b="1" baseline="0" dirty="0" smtClean="0"/>
                        <a:t>(</a:t>
                      </a:r>
                      <a:r>
                        <a:rPr lang="fr-FR" sz="1400" b="1" baseline="0" dirty="0" err="1" smtClean="0"/>
                        <a:t>a.u</a:t>
                      </a:r>
                      <a:r>
                        <a:rPr lang="fr-FR" sz="1400" b="1" baseline="0" dirty="0" smtClean="0"/>
                        <a:t>.) </a:t>
                      </a:r>
                      <a:endParaRPr lang="fr-FR" sz="1400" b="1" dirty="0"/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3440341565"/>
                  </a:ext>
                </a:extLst>
              </a:tr>
              <a:tr h="395412">
                <a:tc rowSpan="2">
                  <a:txBody>
                    <a:bodyPr/>
                    <a:lstStyle/>
                    <a:p>
                      <a:pPr algn="ctr"/>
                      <a:r>
                        <a:rPr lang="fr-FR" sz="1400" b="1" dirty="0" smtClean="0"/>
                        <a:t>EGI-1</a:t>
                      </a:r>
                      <a:endParaRPr lang="fr-FR" sz="1400" b="1" dirty="0"/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2000" b="1" dirty="0" smtClean="0"/>
                        <a:t>-</a:t>
                      </a:r>
                      <a:endParaRPr lang="fr-FR" sz="2000" b="1" dirty="0"/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fr-FR" sz="1600" b="1" dirty="0" smtClean="0"/>
                        <a:t>PBT </a:t>
                      </a:r>
                      <a:r>
                        <a:rPr lang="en-US" sz="1600" b="1" noProof="0" dirty="0" smtClean="0"/>
                        <a:t>deposit</a:t>
                      </a:r>
                      <a:endParaRPr lang="en-US" sz="1600" b="1" noProof="0" dirty="0"/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400" dirty="0" smtClean="0"/>
                        <a:t>2.3 ± 1.5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400" dirty="0" smtClean="0"/>
                        <a:t>12.11 ± 8.4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400" dirty="0" smtClean="0"/>
                        <a:t>0.39 ± 0.2</a:t>
                      </a:r>
                      <a:endParaRPr lang="fr-FR" sz="1400" dirty="0"/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2000" b="1" dirty="0" smtClean="0"/>
                        <a:t>-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658785873"/>
                  </a:ext>
                </a:extLst>
              </a:tr>
              <a:tr h="495927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2000" b="1" dirty="0" smtClean="0"/>
                        <a:t>+</a:t>
                      </a:r>
                      <a:endParaRPr lang="fr-FR" sz="2000" b="1" dirty="0"/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pPr algn="ctr"/>
                      <a:endParaRPr lang="fr-FR" sz="1600" b="1" dirty="0"/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400" dirty="0" smtClean="0"/>
                        <a:t>1.9 ± 1.1</a:t>
                      </a:r>
                      <a:endParaRPr lang="fr-FR" sz="1400" dirty="0"/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400" b="1" dirty="0" smtClean="0"/>
                        <a:t>      15.38</a:t>
                      </a:r>
                      <a:r>
                        <a:rPr lang="fr-FR" sz="1400" b="1" baseline="0" dirty="0" smtClean="0"/>
                        <a:t> </a:t>
                      </a:r>
                      <a:r>
                        <a:rPr lang="fr-FR" sz="1400" b="1" dirty="0" smtClean="0"/>
                        <a:t>± 10.3 ***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400" b="1" smtClean="0"/>
                        <a:t>    </a:t>
                      </a:r>
                      <a:r>
                        <a:rPr lang="fr-FR" sz="1400" b="1" baseline="0" smtClean="0"/>
                        <a:t> </a:t>
                      </a:r>
                      <a:r>
                        <a:rPr lang="fr-FR" sz="1400" b="1" smtClean="0"/>
                        <a:t>0.55 </a:t>
                      </a:r>
                      <a:r>
                        <a:rPr lang="fr-FR" sz="1400" b="1" dirty="0" smtClean="0"/>
                        <a:t>± 0.2 ***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2000" b="1" dirty="0" smtClean="0"/>
                        <a:t>-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2594516385"/>
                  </a:ext>
                </a:extLst>
              </a:tr>
              <a:tr h="395412">
                <a:tc rowSpan="2">
                  <a:txBody>
                    <a:bodyPr/>
                    <a:lstStyle/>
                    <a:p>
                      <a:pPr algn="ctr"/>
                      <a:r>
                        <a:rPr lang="fr-FR" sz="1400" b="1" dirty="0" smtClean="0"/>
                        <a:t>KPC</a:t>
                      </a:r>
                      <a:endParaRPr lang="fr-FR" sz="1400" b="1" dirty="0"/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2000" b="1" dirty="0" smtClean="0"/>
                        <a:t>-</a:t>
                      </a:r>
                      <a:endParaRPr lang="fr-FR" sz="2000" b="1" dirty="0"/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fr-FR" sz="1600" b="1" dirty="0" err="1" smtClean="0"/>
                        <a:t>TILs</a:t>
                      </a:r>
                      <a:endParaRPr lang="fr-FR" sz="1600" b="1" dirty="0"/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400" dirty="0" smtClean="0"/>
                        <a:t>3.6± 2.9</a:t>
                      </a:r>
                      <a:endParaRPr lang="fr-FR" sz="1400" dirty="0"/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400" dirty="0" smtClean="0"/>
                        <a:t>10.8 ± 9.3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400" dirty="0" smtClean="0"/>
                        <a:t>0.4 ± 0.25</a:t>
                      </a:r>
                      <a:endParaRPr lang="fr-FR" sz="1400" dirty="0"/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400" dirty="0" smtClean="0"/>
                        <a:t>252 ± 191</a:t>
                      </a:r>
                      <a:endParaRPr lang="fr-FR" sz="1400" dirty="0"/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3401587048"/>
                  </a:ext>
                </a:extLst>
              </a:tr>
              <a:tr h="469514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2000" b="1" dirty="0" smtClean="0"/>
                        <a:t>+</a:t>
                      </a:r>
                      <a:endParaRPr lang="fr-FR" sz="2000" b="1" dirty="0"/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pPr algn="ctr"/>
                      <a:endParaRPr lang="fr-FR" sz="2000" b="1" dirty="0"/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400" b="0" dirty="0" smtClean="0"/>
                        <a:t>3.9 ± 2.9</a:t>
                      </a:r>
                      <a:endParaRPr lang="fr-FR" sz="1400" b="0" dirty="0"/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400" b="1" dirty="0" smtClean="0"/>
                        <a:t> 14.2 ± 11.1 ***</a:t>
                      </a:r>
                      <a:endParaRPr lang="fr-FR" sz="1400" dirty="0" smtClean="0"/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400" dirty="0" smtClean="0"/>
                        <a:t>0.4 ± 0.24</a:t>
                      </a:r>
                      <a:endParaRPr lang="fr-FR" sz="1400" dirty="0"/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400" b="1" dirty="0" smtClean="0"/>
                        <a:t>    823 ± 591***</a:t>
                      </a:r>
                      <a:endParaRPr lang="fr-FR" sz="1400" b="1" dirty="0"/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435303675"/>
                  </a:ext>
                </a:extLst>
              </a:tr>
              <a:tr h="395412">
                <a:tc rowSpan="2">
                  <a:txBody>
                    <a:bodyPr/>
                    <a:lstStyle/>
                    <a:p>
                      <a:pPr algn="ctr"/>
                      <a:r>
                        <a:rPr lang="fr-FR" sz="1400" b="1" dirty="0" smtClean="0"/>
                        <a:t>MMTV-</a:t>
                      </a:r>
                      <a:r>
                        <a:rPr lang="fr-FR" sz="1400" b="1" dirty="0" err="1" smtClean="0"/>
                        <a:t>PyMT</a:t>
                      </a:r>
                      <a:endParaRPr lang="fr-FR" sz="1400" b="1" dirty="0"/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2000" b="1" dirty="0" smtClean="0"/>
                        <a:t>-</a:t>
                      </a:r>
                      <a:endParaRPr lang="fr-FR" sz="2000" b="1" dirty="0"/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fr-FR" sz="1600" b="1" dirty="0" smtClean="0"/>
                        <a:t>PBT </a:t>
                      </a:r>
                      <a:r>
                        <a:rPr lang="fr-FR" sz="1600" b="1" dirty="0" err="1" smtClean="0"/>
                        <a:t>deposit</a:t>
                      </a:r>
                      <a:endParaRPr lang="fr-FR" sz="1600" b="1" dirty="0" smtClean="0"/>
                    </a:p>
                    <a:p>
                      <a:pPr algn="ctr"/>
                      <a:endParaRPr lang="fr-FR" sz="2000" b="1" dirty="0"/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400" dirty="0" smtClean="0"/>
                        <a:t>4.1</a:t>
                      </a:r>
                      <a:r>
                        <a:rPr lang="fr-FR" sz="1400" baseline="0" dirty="0" smtClean="0"/>
                        <a:t> </a:t>
                      </a:r>
                      <a:r>
                        <a:rPr lang="fr-FR" sz="1400" dirty="0" smtClean="0"/>
                        <a:t>±</a:t>
                      </a:r>
                      <a:r>
                        <a:rPr lang="fr-FR" sz="1400" baseline="0" dirty="0" smtClean="0"/>
                        <a:t> 2.2</a:t>
                      </a:r>
                      <a:endParaRPr lang="fr-FR" sz="1400" dirty="0" smtClean="0"/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400" dirty="0" smtClean="0"/>
                        <a:t>13.15 ± 10.8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400" dirty="0" smtClean="0"/>
                        <a:t>0.4 ± 0.24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2000" b="1" dirty="0" smtClean="0"/>
                        <a:t>-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4159877836"/>
                  </a:ext>
                </a:extLst>
              </a:tr>
              <a:tr h="450581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2000" b="1" dirty="0" smtClean="0"/>
                        <a:t>+</a:t>
                      </a:r>
                      <a:endParaRPr lang="fr-FR" sz="2000" b="1" dirty="0"/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pPr algn="ctr"/>
                      <a:endParaRPr lang="fr-FR" sz="2000" b="1" dirty="0"/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400" dirty="0" smtClean="0"/>
                        <a:t>3.9 ± 2.3</a:t>
                      </a:r>
                      <a:endParaRPr lang="fr-FR" sz="1400" dirty="0"/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400" b="1" dirty="0" smtClean="0"/>
                        <a:t>      17.2</a:t>
                      </a:r>
                      <a:r>
                        <a:rPr lang="fr-FR" sz="1400" b="1" baseline="0" dirty="0" smtClean="0"/>
                        <a:t> </a:t>
                      </a:r>
                      <a:r>
                        <a:rPr lang="fr-FR" sz="1400" b="1" dirty="0" smtClean="0"/>
                        <a:t>± 15.9 ***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400" dirty="0" smtClean="0"/>
                        <a:t>0.4 ± 0.25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2000" b="1" dirty="0" smtClean="0"/>
                        <a:t>-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2414607563"/>
                  </a:ext>
                </a:extLst>
              </a:tr>
              <a:tr h="395412">
                <a:tc rowSpan="2">
                  <a:txBody>
                    <a:bodyPr/>
                    <a:lstStyle/>
                    <a:p>
                      <a:pPr algn="ctr"/>
                      <a:r>
                        <a:rPr lang="fr-FR" sz="1400" b="1" dirty="0" err="1" smtClean="0"/>
                        <a:t>mPDAC</a:t>
                      </a:r>
                      <a:endParaRPr lang="fr-FR" sz="1400" b="1" dirty="0"/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2000" b="1" dirty="0" smtClean="0"/>
                        <a:t>-</a:t>
                      </a:r>
                      <a:endParaRPr lang="fr-FR" sz="2000" b="1" dirty="0"/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fr-FR" sz="1600" b="1" dirty="0" err="1" smtClean="0"/>
                        <a:t>TILs</a:t>
                      </a:r>
                      <a:endParaRPr lang="fr-FR" sz="2000" b="1" dirty="0"/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400" baseline="0" dirty="0" smtClean="0"/>
                        <a:t> 1.0 </a:t>
                      </a:r>
                      <a:r>
                        <a:rPr lang="fr-FR" sz="1400" dirty="0" smtClean="0"/>
                        <a:t>±</a:t>
                      </a:r>
                      <a:r>
                        <a:rPr lang="fr-FR" sz="1400" baseline="0" dirty="0" smtClean="0"/>
                        <a:t> 0.5</a:t>
                      </a:r>
                      <a:endParaRPr lang="fr-FR" sz="1400" dirty="0" smtClean="0"/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400" baseline="0" dirty="0" smtClean="0"/>
                        <a:t> 2.03 </a:t>
                      </a:r>
                      <a:r>
                        <a:rPr lang="fr-FR" sz="1400" dirty="0" smtClean="0"/>
                        <a:t>±</a:t>
                      </a:r>
                      <a:r>
                        <a:rPr lang="fr-FR" sz="1400" baseline="0" dirty="0" smtClean="0"/>
                        <a:t> 1.4</a:t>
                      </a:r>
                      <a:endParaRPr lang="fr-FR" sz="1400" dirty="0" smtClean="0"/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400" dirty="0" smtClean="0"/>
                        <a:t>0.1 ± 0.1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400" dirty="0" smtClean="0"/>
                        <a:t>15.7 ± 10</a:t>
                      </a:r>
                      <a:endParaRPr lang="fr-FR" sz="1400" dirty="0"/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931434032"/>
                  </a:ext>
                </a:extLst>
              </a:tr>
              <a:tr h="395412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2000" b="1" dirty="0" smtClean="0"/>
                        <a:t>+</a:t>
                      </a:r>
                      <a:endParaRPr lang="fr-FR" sz="2000" b="1" dirty="0"/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pPr algn="ctr"/>
                      <a:endParaRPr lang="fr-FR" sz="2000" b="1" dirty="0"/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400" b="1" dirty="0" smtClean="0"/>
                        <a:t>1.6 ± 0.8 *</a:t>
                      </a:r>
                      <a:endParaRPr lang="fr-FR" sz="1400" b="1" dirty="0"/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400" b="1" dirty="0" smtClean="0"/>
                        <a:t>   8.8 ± 6.2 ***</a:t>
                      </a:r>
                      <a:endParaRPr lang="fr-FR" sz="1400" b="1" dirty="0"/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400" b="1" dirty="0" smtClean="0"/>
                        <a:t>0.5 ± 0.26 *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400" b="0" dirty="0" smtClean="0"/>
                        <a:t>21.2 ± 17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801638762"/>
                  </a:ext>
                </a:extLst>
              </a:tr>
            </a:tbl>
          </a:graphicData>
        </a:graphic>
      </p:graphicFrame>
      <p:sp>
        <p:nvSpPr>
          <p:cNvPr id="10" name="ZoneTexte 9"/>
          <p:cNvSpPr txBox="1"/>
          <p:nvPr/>
        </p:nvSpPr>
        <p:spPr>
          <a:xfrm>
            <a:off x="8964462" y="4147393"/>
            <a:ext cx="8229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fr-FR" dirty="0"/>
          </a:p>
        </p:txBody>
      </p:sp>
      <p:pic>
        <p:nvPicPr>
          <p:cNvPr id="13" name="Image 12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25359"/>
          <a:stretch/>
        </p:blipFill>
        <p:spPr>
          <a:xfrm>
            <a:off x="9075271" y="1137253"/>
            <a:ext cx="2886060" cy="2085503"/>
          </a:xfrm>
          <a:prstGeom prst="rect">
            <a:avLst/>
          </a:prstGeom>
        </p:spPr>
      </p:pic>
      <p:pic>
        <p:nvPicPr>
          <p:cNvPr id="14" name="Image 13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25948"/>
          <a:stretch/>
        </p:blipFill>
        <p:spPr>
          <a:xfrm>
            <a:off x="9075271" y="3432539"/>
            <a:ext cx="2886060" cy="2102096"/>
          </a:xfrm>
          <a:prstGeom prst="rect">
            <a:avLst/>
          </a:prstGeom>
        </p:spPr>
      </p:pic>
      <p:sp>
        <p:nvSpPr>
          <p:cNvPr id="3" name="ZoneTexte 2"/>
          <p:cNvSpPr txBox="1"/>
          <p:nvPr/>
        </p:nvSpPr>
        <p:spPr>
          <a:xfrm>
            <a:off x="10891654" y="1188589"/>
            <a:ext cx="131121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b="1" dirty="0" err="1" smtClean="0">
                <a:solidFill>
                  <a:schemeClr val="bg1"/>
                </a:solidFill>
              </a:rPr>
              <a:t>Control</a:t>
            </a:r>
            <a:r>
              <a:rPr lang="fr-FR" b="1" dirty="0" err="1" smtClean="0"/>
              <a:t>l</a:t>
            </a:r>
            <a:endParaRPr lang="fr-FR" b="1" dirty="0"/>
          </a:p>
        </p:txBody>
      </p:sp>
      <p:sp>
        <p:nvSpPr>
          <p:cNvPr id="16" name="ZoneTexte 15"/>
          <p:cNvSpPr txBox="1"/>
          <p:nvPr/>
        </p:nvSpPr>
        <p:spPr>
          <a:xfrm>
            <a:off x="11159073" y="3432539"/>
            <a:ext cx="131121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b="1" dirty="0" err="1" smtClean="0">
                <a:solidFill>
                  <a:schemeClr val="bg1"/>
                </a:solidFill>
              </a:rPr>
              <a:t>BAPN</a:t>
            </a:r>
            <a:r>
              <a:rPr lang="fr-FR" b="1" dirty="0" err="1" smtClean="0"/>
              <a:t>l</a:t>
            </a:r>
            <a:endParaRPr lang="fr-FR" b="1" dirty="0"/>
          </a:p>
        </p:txBody>
      </p:sp>
      <p:pic>
        <p:nvPicPr>
          <p:cNvPr id="2" name="Image 1"/>
          <p:cNvPicPr>
            <a:picLocks noChangeAspect="1"/>
          </p:cNvPicPr>
          <p:nvPr/>
        </p:nvPicPr>
        <p:blipFill rotWithShape="1">
          <a:blip r:embed="rId5" cstate="print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backgroundRemoval t="87199" b="92950" l="63626" r="88369">
                        <a14:foregroundMark x1="67047" y1="88868" x2="67161" y2="88868"/>
                        <a14:foregroundMark x1="67047" y1="89981" x2="67047" y2="89981"/>
                        <a14:foregroundMark x1="67047" y1="90724" x2="67047" y2="90724"/>
                        <a14:foregroundMark x1="67161" y1="92022" x2="67161" y2="92022"/>
                        <a14:foregroundMark x1="66477" y1="91095" x2="66477" y2="91095"/>
                        <a14:foregroundMark x1="66477" y1="92022" x2="66477" y2="92022"/>
                        <a14:foregroundMark x1="66819" y1="92579" x2="66819" y2="92579"/>
                        <a14:foregroundMark x1="66705" y1="88868" x2="66705" y2="88868"/>
                        <a14:foregroundMark x1="66135" y1="90538" x2="66135" y2="90538"/>
                        <a14:foregroundMark x1="65564" y1="92393" x2="65564" y2="92393"/>
                        <a14:foregroundMark x1="66135" y1="92393" x2="66135" y2="92393"/>
                        <a14:foregroundMark x1="65564" y1="91280" x2="65564" y2="91280"/>
                        <a14:foregroundMark x1="66135" y1="91651" x2="66135" y2="91651"/>
                        <a14:foregroundMark x1="65222" y1="92393" x2="65222" y2="92393"/>
                        <a14:foregroundMark x1="64766" y1="91466" x2="64766" y2="91466"/>
                        <a14:foregroundMark x1="64196" y1="91651" x2="64196" y2="91651"/>
                        <a14:foregroundMark x1="64424" y1="90538" x2="64424" y2="90538"/>
                        <a14:foregroundMark x1="64652" y1="92579" x2="64652" y2="92579"/>
                        <a14:foregroundMark x1="67959" y1="92022" x2="67959" y2="92022"/>
                        <a14:foregroundMark x1="67389" y1="92022" x2="67389" y2="92022"/>
                        <a14:foregroundMark x1="67731" y1="89981" x2="67731" y2="89981"/>
                        <a14:foregroundMark x1="67959" y1="90909" x2="67959" y2="90909"/>
                        <a14:foregroundMark x1="67617" y1="92579" x2="67617" y2="92579"/>
                        <a14:foregroundMark x1="67959" y1="89425" x2="67959" y2="89425"/>
                        <a14:foregroundMark x1="68871" y1="89981" x2="68871" y2="89981"/>
                        <a14:foregroundMark x1="68871" y1="90724" x2="68871" y2="90724"/>
                        <a14:foregroundMark x1="68643" y1="89425" x2="68643" y2="89425"/>
                        <a14:foregroundMark x1="69555" y1="89425" x2="69555" y2="89425"/>
                        <a14:foregroundMark x1="69213" y1="90353" x2="69213" y2="90353"/>
                        <a14:foregroundMark x1="69555" y1="90724" x2="69555" y2="90724"/>
                        <a14:foregroundMark x1="70125" y1="89610" x2="70125" y2="89610"/>
                        <a14:foregroundMark x1="70353" y1="89981" x2="70353" y2="89981"/>
                        <a14:foregroundMark x1="70582" y1="90353" x2="70582" y2="90353"/>
                        <a14:foregroundMark x1="70582" y1="89610" x2="70582" y2="89610"/>
                        <a14:foregroundMark x1="70125" y1="89054" x2="70125" y2="89054"/>
                        <a14:foregroundMark x1="82782" y1="91837" x2="82782" y2="91837"/>
                        <a14:foregroundMark x1="82896" y1="90909" x2="82896" y2="90909"/>
                        <a14:foregroundMark x1="83466" y1="91651" x2="83466" y2="91651"/>
                        <a14:foregroundMark x1="83922" y1="91837" x2="83922" y2="91837"/>
                        <a14:foregroundMark x1="84036" y1="91095" x2="84036" y2="91095"/>
                        <a14:foregroundMark x1="83352" y1="90909" x2="83352" y2="90909"/>
                        <a14:foregroundMark x1="71380" y1="89239" x2="71380" y2="89239"/>
                        <a14:foregroundMark x1="72292" y1="89610" x2="72292" y2="89610"/>
                        <a14:foregroundMark x1="71950" y1="90538" x2="71950" y2="90538"/>
                        <a14:foregroundMark x1="71836" y1="88683" x2="71836" y2="88683"/>
                        <a14:foregroundMark x1="71494" y1="90724" x2="71494" y2="90724"/>
                        <a14:foregroundMark x1="72748" y1="90167" x2="72748" y2="90167"/>
                        <a14:foregroundMark x1="72748" y1="89796" x2="72748" y2="89796"/>
                        <a14:foregroundMark x1="72634" y1="88868" x2="72634" y2="88868"/>
                        <a14:foregroundMark x1="73546" y1="89425" x2="73546" y2="89425"/>
                        <a14:foregroundMark x1="73660" y1="90538" x2="73660" y2="90538"/>
                        <a14:foregroundMark x1="73318" y1="89239" x2="73318" y2="89239"/>
                        <a14:foregroundMark x1="74002" y1="89981" x2="74002" y2="89981"/>
                        <a14:foregroundMark x1="74572" y1="89610" x2="74572" y2="89610"/>
                        <a14:foregroundMark x1="74572" y1="90353" x2="74572" y2="90353"/>
                        <a14:foregroundMark x1="74800" y1="89425" x2="74800" y2="89425"/>
                        <a14:foregroundMark x1="74914" y1="89981" x2="74914" y2="89981"/>
                        <a14:foregroundMark x1="74914" y1="90724" x2="74914" y2="90724"/>
                        <a14:foregroundMark x1="74914" y1="89054" x2="74914" y2="89054"/>
                        <a14:foregroundMark x1="75827" y1="89981" x2="75827" y2="89981"/>
                        <a14:foregroundMark x1="75713" y1="90538" x2="75713" y2="90538"/>
                        <a14:foregroundMark x1="75599" y1="89239" x2="75599" y2="89239"/>
                        <a14:foregroundMark x1="75257" y1="89239" x2="75257" y2="89239"/>
                        <a14:foregroundMark x1="76397" y1="89425" x2="76397" y2="89425"/>
                        <a14:foregroundMark x1="76397" y1="90724" x2="76397" y2="90724"/>
                        <a14:foregroundMark x1="76055" y1="90167" x2="76055" y2="90167"/>
                        <a14:foregroundMark x1="77309" y1="89981" x2="77309" y2="89981"/>
                        <a14:foregroundMark x1="77651" y1="89796" x2="77651" y2="89796"/>
                        <a14:foregroundMark x1="76967" y1="89425" x2="76967" y2="89425"/>
                        <a14:foregroundMark x1="77993" y1="89796" x2="77993" y2="89796"/>
                        <a14:foregroundMark x1="78449" y1="89610" x2="78449" y2="89610"/>
                        <a14:foregroundMark x1="78905" y1="89425" x2="78905" y2="89425"/>
                        <a14:foregroundMark x1="79019" y1="90353" x2="79019" y2="90353"/>
                        <a14:foregroundMark x1="79704" y1="89981" x2="79704" y2="89981"/>
                        <a14:foregroundMark x1="79361" y1="89796" x2="79361" y2="89796"/>
                        <a14:foregroundMark x1="79818" y1="89239" x2="79818" y2="89239"/>
                        <a14:foregroundMark x1="79818" y1="90724" x2="79818" y2="90724"/>
                        <a14:foregroundMark x1="80388" y1="90353" x2="80388" y2="90353"/>
                        <a14:foregroundMark x1="80502" y1="89610" x2="80502" y2="89610"/>
                        <a14:foregroundMark x1="80958" y1="90167" x2="80958" y2="90167"/>
                        <a14:foregroundMark x1="81186" y1="89425" x2="81186" y2="89425"/>
                        <a14:foregroundMark x1="81300" y1="90353" x2="81300" y2="90353"/>
                        <a14:foregroundMark x1="82098" y1="89610" x2="82098" y2="89610"/>
                        <a14:foregroundMark x1="82098" y1="89054" x2="82098" y2="89054"/>
                        <a14:foregroundMark x1="82326" y1="90538" x2="82326" y2="90538"/>
                        <a14:foregroundMark x1="83124" y1="89981" x2="83124" y2="89981"/>
                        <a14:foregroundMark x1="83580" y1="89796" x2="83580" y2="89796"/>
                        <a14:foregroundMark x1="83466" y1="89239" x2="83466" y2="89239"/>
                        <a14:foregroundMark x1="83694" y1="90724" x2="83694" y2="90724"/>
                        <a14:foregroundMark x1="84036" y1="90353" x2="84036" y2="90353"/>
                        <a14:foregroundMark x1="84036" y1="89796" x2="84036" y2="89796"/>
                        <a14:foregroundMark x1="84607" y1="89425" x2="84607" y2="89425"/>
                        <a14:foregroundMark x1="84607" y1="90353" x2="84607" y2="90353"/>
                        <a14:foregroundMark x1="85519" y1="90167" x2="85519" y2="90167"/>
                        <a14:foregroundMark x1="85519" y1="89610" x2="85519" y2="89610"/>
                        <a14:foregroundMark x1="84949" y1="89425" x2="84949" y2="89425"/>
                        <a14:foregroundMark x1="84949" y1="90538" x2="84949" y2="90538"/>
                        <a14:foregroundMark x1="85405" y1="91095" x2="85405" y2="91095"/>
                        <a14:foregroundMark x1="84949" y1="91095" x2="84949" y2="91095"/>
                        <a14:foregroundMark x1="85747" y1="89425" x2="85747" y2="89425"/>
                        <a14:foregroundMark x1="85861" y1="90353" x2="85861" y2="90353"/>
                        <a14:foregroundMark x1="86203" y1="89610" x2="86203" y2="89610"/>
                        <a14:foregroundMark x1="86203" y1="89054" x2="86203" y2="89054"/>
                        <a14:foregroundMark x1="86887" y1="89610" x2="86887" y2="89610"/>
                        <a14:foregroundMark x1="86317" y1="90353" x2="86317" y2="90353"/>
                        <a14:foregroundMark x1="86887" y1="90353" x2="86887" y2="90353"/>
                        <a14:foregroundMark x1="83694" y1="92579" x2="83694" y2="92579"/>
                        <a14:foregroundMark x1="84721" y1="92579" x2="84721" y2="92579"/>
                        <a14:foregroundMark x1="84265" y1="91651" x2="84265" y2="91651"/>
                        <a14:foregroundMark x1="85633" y1="91837" x2="85633" y2="91837"/>
                        <a14:foregroundMark x1="85405" y1="92579" x2="85405" y2="92579"/>
                        <a14:foregroundMark x1="86089" y1="92579" x2="86089" y2="92393"/>
                        <a14:foregroundMark x1="86545" y1="91651" x2="86545" y2="91651"/>
                        <a14:foregroundMark x1="86545" y1="92208" x2="86545" y2="92208"/>
                        <a14:foregroundMark x1="87229" y1="92208" x2="87229" y2="92208"/>
                        <a14:foregroundMark x1="87229" y1="91466" x2="87229" y2="91466"/>
                        <a14:foregroundMark x1="87457" y1="91095" x2="87457" y2="91095"/>
                        <a14:foregroundMark x1="87571" y1="92022" x2="87571" y2="92022"/>
                        <a14:foregroundMark x1="88141" y1="92393" x2="88141" y2="92393"/>
                        <a14:foregroundMark x1="88027" y1="91280" x2="88027" y2="91280"/>
                      </a14:backgroundRemoval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63592" t="86501" r="11248" b="6239"/>
          <a:stretch/>
        </p:blipFill>
        <p:spPr>
          <a:xfrm>
            <a:off x="9075271" y="5364622"/>
            <a:ext cx="865452" cy="153479"/>
          </a:xfrm>
          <a:prstGeom prst="rect">
            <a:avLst/>
          </a:prstGeom>
        </p:spPr>
      </p:pic>
      <p:pic>
        <p:nvPicPr>
          <p:cNvPr id="9" name="Image 8"/>
          <p:cNvPicPr>
            <a:picLocks noChangeAspect="1"/>
          </p:cNvPicPr>
          <p:nvPr/>
        </p:nvPicPr>
        <p:blipFill rotWithShape="1">
          <a:blip r:embed="rId5" cstate="print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backgroundRemoval t="87199" b="92950" l="63626" r="88369">
                        <a14:foregroundMark x1="67047" y1="88868" x2="67161" y2="88868"/>
                        <a14:foregroundMark x1="67047" y1="89981" x2="67047" y2="89981"/>
                        <a14:foregroundMark x1="67047" y1="90724" x2="67047" y2="90724"/>
                        <a14:foregroundMark x1="67161" y1="92022" x2="67161" y2="92022"/>
                        <a14:foregroundMark x1="66477" y1="91095" x2="66477" y2="91095"/>
                        <a14:foregroundMark x1="66477" y1="92022" x2="66477" y2="92022"/>
                        <a14:foregroundMark x1="66819" y1="92579" x2="66819" y2="92579"/>
                        <a14:foregroundMark x1="66705" y1="88868" x2="66705" y2="88868"/>
                        <a14:foregroundMark x1="66135" y1="90538" x2="66135" y2="90538"/>
                        <a14:foregroundMark x1="65564" y1="92393" x2="65564" y2="92393"/>
                        <a14:foregroundMark x1="66135" y1="92393" x2="66135" y2="92393"/>
                        <a14:foregroundMark x1="65564" y1="91280" x2="65564" y2="91280"/>
                        <a14:foregroundMark x1="66135" y1="91651" x2="66135" y2="91651"/>
                        <a14:foregroundMark x1="65222" y1="92393" x2="65222" y2="92393"/>
                        <a14:foregroundMark x1="64766" y1="91466" x2="64766" y2="91466"/>
                        <a14:foregroundMark x1="64196" y1="91651" x2="64196" y2="91651"/>
                        <a14:foregroundMark x1="64424" y1="90538" x2="64424" y2="90538"/>
                        <a14:foregroundMark x1="64652" y1="92579" x2="64652" y2="92579"/>
                        <a14:foregroundMark x1="67959" y1="92022" x2="67959" y2="92022"/>
                        <a14:foregroundMark x1="67389" y1="92022" x2="67389" y2="92022"/>
                        <a14:foregroundMark x1="67731" y1="89981" x2="67731" y2="89981"/>
                        <a14:foregroundMark x1="67959" y1="90909" x2="67959" y2="90909"/>
                        <a14:foregroundMark x1="67617" y1="92579" x2="67617" y2="92579"/>
                        <a14:foregroundMark x1="67959" y1="89425" x2="67959" y2="89425"/>
                        <a14:foregroundMark x1="68871" y1="89981" x2="68871" y2="89981"/>
                        <a14:foregroundMark x1="68871" y1="90724" x2="68871" y2="90724"/>
                        <a14:foregroundMark x1="68643" y1="89425" x2="68643" y2="89425"/>
                        <a14:foregroundMark x1="69555" y1="89425" x2="69555" y2="89425"/>
                        <a14:foregroundMark x1="69213" y1="90353" x2="69213" y2="90353"/>
                        <a14:foregroundMark x1="69555" y1="90724" x2="69555" y2="90724"/>
                        <a14:foregroundMark x1="70125" y1="89610" x2="70125" y2="89610"/>
                        <a14:foregroundMark x1="70353" y1="89981" x2="70353" y2="89981"/>
                        <a14:foregroundMark x1="70582" y1="90353" x2="70582" y2="90353"/>
                        <a14:foregroundMark x1="70582" y1="89610" x2="70582" y2="89610"/>
                        <a14:foregroundMark x1="70125" y1="89054" x2="70125" y2="89054"/>
                        <a14:foregroundMark x1="82782" y1="91837" x2="82782" y2="91837"/>
                        <a14:foregroundMark x1="82896" y1="90909" x2="82896" y2="90909"/>
                        <a14:foregroundMark x1="83466" y1="91651" x2="83466" y2="91651"/>
                        <a14:foregroundMark x1="83922" y1="91837" x2="83922" y2="91837"/>
                        <a14:foregroundMark x1="84036" y1="91095" x2="84036" y2="91095"/>
                        <a14:foregroundMark x1="83352" y1="90909" x2="83352" y2="90909"/>
                        <a14:foregroundMark x1="71380" y1="89239" x2="71380" y2="89239"/>
                        <a14:foregroundMark x1="72292" y1="89610" x2="72292" y2="89610"/>
                        <a14:foregroundMark x1="71950" y1="90538" x2="71950" y2="90538"/>
                        <a14:foregroundMark x1="71836" y1="88683" x2="71836" y2="88683"/>
                        <a14:foregroundMark x1="71494" y1="90724" x2="71494" y2="90724"/>
                        <a14:foregroundMark x1="72748" y1="90167" x2="72748" y2="90167"/>
                        <a14:foregroundMark x1="72748" y1="89796" x2="72748" y2="89796"/>
                        <a14:foregroundMark x1="72634" y1="88868" x2="72634" y2="88868"/>
                        <a14:foregroundMark x1="73546" y1="89425" x2="73546" y2="89425"/>
                        <a14:foregroundMark x1="73660" y1="90538" x2="73660" y2="90538"/>
                        <a14:foregroundMark x1="73318" y1="89239" x2="73318" y2="89239"/>
                        <a14:foregroundMark x1="74002" y1="89981" x2="74002" y2="89981"/>
                        <a14:foregroundMark x1="74572" y1="89610" x2="74572" y2="89610"/>
                        <a14:foregroundMark x1="74572" y1="90353" x2="74572" y2="90353"/>
                        <a14:foregroundMark x1="74800" y1="89425" x2="74800" y2="89425"/>
                        <a14:foregroundMark x1="74914" y1="89981" x2="74914" y2="89981"/>
                        <a14:foregroundMark x1="74914" y1="90724" x2="74914" y2="90724"/>
                        <a14:foregroundMark x1="74914" y1="89054" x2="74914" y2="89054"/>
                        <a14:foregroundMark x1="75827" y1="89981" x2="75827" y2="89981"/>
                        <a14:foregroundMark x1="75713" y1="90538" x2="75713" y2="90538"/>
                        <a14:foregroundMark x1="75599" y1="89239" x2="75599" y2="89239"/>
                        <a14:foregroundMark x1="75257" y1="89239" x2="75257" y2="89239"/>
                        <a14:foregroundMark x1="76397" y1="89425" x2="76397" y2="89425"/>
                        <a14:foregroundMark x1="76397" y1="90724" x2="76397" y2="90724"/>
                        <a14:foregroundMark x1="76055" y1="90167" x2="76055" y2="90167"/>
                        <a14:foregroundMark x1="77309" y1="89981" x2="77309" y2="89981"/>
                        <a14:foregroundMark x1="77651" y1="89796" x2="77651" y2="89796"/>
                        <a14:foregroundMark x1="76967" y1="89425" x2="76967" y2="89425"/>
                        <a14:foregroundMark x1="77993" y1="89796" x2="77993" y2="89796"/>
                        <a14:foregroundMark x1="78449" y1="89610" x2="78449" y2="89610"/>
                        <a14:foregroundMark x1="78905" y1="89425" x2="78905" y2="89425"/>
                        <a14:foregroundMark x1="79019" y1="90353" x2="79019" y2="90353"/>
                        <a14:foregroundMark x1="79704" y1="89981" x2="79704" y2="89981"/>
                        <a14:foregroundMark x1="79361" y1="89796" x2="79361" y2="89796"/>
                        <a14:foregroundMark x1="79818" y1="89239" x2="79818" y2="89239"/>
                        <a14:foregroundMark x1="79818" y1="90724" x2="79818" y2="90724"/>
                        <a14:foregroundMark x1="80388" y1="90353" x2="80388" y2="90353"/>
                        <a14:foregroundMark x1="80502" y1="89610" x2="80502" y2="89610"/>
                        <a14:foregroundMark x1="80958" y1="90167" x2="80958" y2="90167"/>
                        <a14:foregroundMark x1="81186" y1="89425" x2="81186" y2="89425"/>
                        <a14:foregroundMark x1="81300" y1="90353" x2="81300" y2="90353"/>
                        <a14:foregroundMark x1="82098" y1="89610" x2="82098" y2="89610"/>
                        <a14:foregroundMark x1="82098" y1="89054" x2="82098" y2="89054"/>
                        <a14:foregroundMark x1="82326" y1="90538" x2="82326" y2="90538"/>
                        <a14:foregroundMark x1="83124" y1="89981" x2="83124" y2="89981"/>
                        <a14:foregroundMark x1="83580" y1="89796" x2="83580" y2="89796"/>
                        <a14:foregroundMark x1="83466" y1="89239" x2="83466" y2="89239"/>
                        <a14:foregroundMark x1="83694" y1="90724" x2="83694" y2="90724"/>
                        <a14:foregroundMark x1="84036" y1="90353" x2="84036" y2="90353"/>
                        <a14:foregroundMark x1="84036" y1="89796" x2="84036" y2="89796"/>
                        <a14:foregroundMark x1="84607" y1="89425" x2="84607" y2="89425"/>
                        <a14:foregroundMark x1="84607" y1="90353" x2="84607" y2="90353"/>
                        <a14:foregroundMark x1="85519" y1="90167" x2="85519" y2="90167"/>
                        <a14:foregroundMark x1="85519" y1="89610" x2="85519" y2="89610"/>
                        <a14:foregroundMark x1="84949" y1="89425" x2="84949" y2="89425"/>
                        <a14:foregroundMark x1="84949" y1="90538" x2="84949" y2="90538"/>
                        <a14:foregroundMark x1="85405" y1="91095" x2="85405" y2="91095"/>
                        <a14:foregroundMark x1="84949" y1="91095" x2="84949" y2="91095"/>
                        <a14:foregroundMark x1="85747" y1="89425" x2="85747" y2="89425"/>
                        <a14:foregroundMark x1="85861" y1="90353" x2="85861" y2="90353"/>
                        <a14:foregroundMark x1="86203" y1="89610" x2="86203" y2="89610"/>
                        <a14:foregroundMark x1="86203" y1="89054" x2="86203" y2="89054"/>
                        <a14:foregroundMark x1="86887" y1="89610" x2="86887" y2="89610"/>
                        <a14:foregroundMark x1="86317" y1="90353" x2="86317" y2="90353"/>
                        <a14:foregroundMark x1="86887" y1="90353" x2="86887" y2="90353"/>
                        <a14:foregroundMark x1="83694" y1="92579" x2="83694" y2="92579"/>
                        <a14:foregroundMark x1="84721" y1="92579" x2="84721" y2="92579"/>
                        <a14:foregroundMark x1="84265" y1="91651" x2="84265" y2="91651"/>
                        <a14:foregroundMark x1="85633" y1="91837" x2="85633" y2="91837"/>
                        <a14:foregroundMark x1="85405" y1="92579" x2="85405" y2="92579"/>
                        <a14:foregroundMark x1="86089" y1="92579" x2="86089" y2="92393"/>
                        <a14:foregroundMark x1="86545" y1="91651" x2="86545" y2="91651"/>
                        <a14:foregroundMark x1="86545" y1="92208" x2="86545" y2="92208"/>
                        <a14:foregroundMark x1="87229" y1="92208" x2="87229" y2="92208"/>
                        <a14:foregroundMark x1="87229" y1="91466" x2="87229" y2="91466"/>
                        <a14:foregroundMark x1="87457" y1="91095" x2="87457" y2="91095"/>
                        <a14:foregroundMark x1="87571" y1="92022" x2="87571" y2="92022"/>
                        <a14:foregroundMark x1="88141" y1="92393" x2="88141" y2="92393"/>
                        <a14:foregroundMark x1="88027" y1="91280" x2="88027" y2="91280"/>
                      </a14:backgroundRemoval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63592" t="86501" r="11248" b="6239"/>
          <a:stretch/>
        </p:blipFill>
        <p:spPr>
          <a:xfrm>
            <a:off x="9132421" y="3027872"/>
            <a:ext cx="865452" cy="153479"/>
          </a:xfrm>
          <a:prstGeom prst="rect">
            <a:avLst/>
          </a:prstGeom>
        </p:spPr>
      </p:pic>
      <p:sp>
        <p:nvSpPr>
          <p:cNvPr id="4" name="ZoneTexte 3"/>
          <p:cNvSpPr txBox="1"/>
          <p:nvPr/>
        </p:nvSpPr>
        <p:spPr>
          <a:xfrm>
            <a:off x="497941" y="669956"/>
            <a:ext cx="216379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err="1" smtClean="0"/>
              <a:t>Supplementary</a:t>
            </a:r>
            <a:r>
              <a:rPr lang="fr-FR" dirty="0" smtClean="0"/>
              <a:t> File 4</a:t>
            </a:r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6024888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769</TotalTime>
  <Words>153</Words>
  <Application>Microsoft Office PowerPoint</Application>
  <PresentationFormat>Personnalisé</PresentationFormat>
  <Paragraphs>61</Paragraphs>
  <Slides>1</Slides>
  <Notes>1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2" baseType="lpstr">
      <vt:lpstr>Thème Office</vt:lpstr>
      <vt:lpstr>Présentation PowerPoint</vt:lpstr>
    </vt:vector>
  </TitlesOfParts>
  <Company>Hewlett-Packard Company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Alba Nicolas-Boluda</dc:creator>
  <cp:lastModifiedBy>Emmanuel Donnadieu</cp:lastModifiedBy>
  <cp:revision>17</cp:revision>
  <dcterms:created xsi:type="dcterms:W3CDTF">2021-04-21T20:46:35Z</dcterms:created>
  <dcterms:modified xsi:type="dcterms:W3CDTF">2021-06-01T16:22:22Z</dcterms:modified>
</cp:coreProperties>
</file>